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595"/>
  </p:normalViewPr>
  <p:slideViewPr>
    <p:cSldViewPr snapToGrid="0">
      <p:cViewPr varScale="1">
        <p:scale>
          <a:sx n="108" d="100"/>
          <a:sy n="108" d="100"/>
        </p:scale>
        <p:origin x="1704" y="108"/>
      </p:cViewPr>
      <p:guideLst/>
    </p:cSldViewPr>
  </p:slideViewPr>
  <p:notesTextViewPr>
    <p:cViewPr>
      <p:scale>
        <a:sx n="125" d="100"/>
        <a:sy n="12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ura Martinez Verbo" userId="4d37ebe3-7a81-4ffc-b516-02451072dc6d" providerId="ADAL" clId="{F4886666-ED43-4530-9179-1FC9ED581FF0}"/>
    <pc:docChg chg="undo custSel addSld delSld modSld modMainMaster">
      <pc:chgData name="Laura Martinez Verbo" userId="4d37ebe3-7a81-4ffc-b516-02451072dc6d" providerId="ADAL" clId="{F4886666-ED43-4530-9179-1FC9ED581FF0}" dt="2022-02-01T11:32:38.362" v="1271" actId="20577"/>
      <pc:docMkLst>
        <pc:docMk/>
      </pc:docMkLst>
      <pc:sldChg chg="addSp delSp modSp add">
        <pc:chgData name="Laura Martinez Verbo" userId="4d37ebe3-7a81-4ffc-b516-02451072dc6d" providerId="ADAL" clId="{F4886666-ED43-4530-9179-1FC9ED581FF0}" dt="2022-02-01T11:32:38.362" v="1271" actId="20577"/>
        <pc:sldMkLst>
          <pc:docMk/>
          <pc:sldMk cId="3716414647" sldId="257"/>
        </pc:sldMkLst>
        <pc:spChg chg="del">
          <ac:chgData name="Laura Martinez Verbo" userId="4d37ebe3-7a81-4ffc-b516-02451072dc6d" providerId="ADAL" clId="{F4886666-ED43-4530-9179-1FC9ED581FF0}" dt="2022-01-30T08:41:17.358" v="15" actId="478"/>
          <ac:spMkLst>
            <pc:docMk/>
            <pc:sldMk cId="3716414647" sldId="257"/>
            <ac:spMk id="2" creationId="{5A23D8AB-84B1-0646-88F2-77FD117B4594}"/>
          </ac:spMkLst>
        </pc:spChg>
        <pc:spChg chg="mod">
          <ac:chgData name="Laura Martinez Verbo" userId="4d37ebe3-7a81-4ffc-b516-02451072dc6d" providerId="ADAL" clId="{F4886666-ED43-4530-9179-1FC9ED581FF0}" dt="2022-01-30T09:42:34.313" v="1186" actId="1076"/>
          <ac:spMkLst>
            <pc:docMk/>
            <pc:sldMk cId="3716414647" sldId="257"/>
            <ac:spMk id="4" creationId="{03843FA6-A6E6-7049-AC71-CA2061E0CD3A}"/>
          </ac:spMkLst>
        </pc:spChg>
        <pc:spChg chg="add mod">
          <ac:chgData name="Laura Martinez Verbo" userId="4d37ebe3-7a81-4ffc-b516-02451072dc6d" providerId="ADAL" clId="{F4886666-ED43-4530-9179-1FC9ED581FF0}" dt="2022-01-31T08:44:29.372" v="1236" actId="1076"/>
          <ac:spMkLst>
            <pc:docMk/>
            <pc:sldMk cId="3716414647" sldId="257"/>
            <ac:spMk id="5" creationId="{6C58BE1E-48F7-42E7-B270-13204E53AD1F}"/>
          </ac:spMkLst>
        </pc:spChg>
        <pc:spChg chg="add mod">
          <ac:chgData name="Laura Martinez Verbo" userId="4d37ebe3-7a81-4ffc-b516-02451072dc6d" providerId="ADAL" clId="{F4886666-ED43-4530-9179-1FC9ED581FF0}" dt="2022-02-01T11:32:38.362" v="1271" actId="20577"/>
          <ac:spMkLst>
            <pc:docMk/>
            <pc:sldMk cId="3716414647" sldId="257"/>
            <ac:spMk id="20" creationId="{CF308175-314E-4F41-9037-F3D03B721207}"/>
          </ac:spMkLst>
        </pc:spChg>
        <pc:spChg chg="del">
          <ac:chgData name="Laura Martinez Verbo" userId="4d37ebe3-7a81-4ffc-b516-02451072dc6d" providerId="ADAL" clId="{F4886666-ED43-4530-9179-1FC9ED581FF0}" dt="2022-01-30T08:41:14.134" v="11" actId="478"/>
          <ac:spMkLst>
            <pc:docMk/>
            <pc:sldMk cId="3716414647" sldId="257"/>
            <ac:spMk id="22" creationId="{54FF0707-15BB-174C-9205-855078631ABD}"/>
          </ac:spMkLst>
        </pc:spChg>
        <pc:spChg chg="mod">
          <ac:chgData name="Laura Martinez Verbo" userId="4d37ebe3-7a81-4ffc-b516-02451072dc6d" providerId="ADAL" clId="{F4886666-ED43-4530-9179-1FC9ED581FF0}" dt="2022-01-30T08:40:07.681" v="6" actId="20577"/>
          <ac:spMkLst>
            <pc:docMk/>
            <pc:sldMk cId="3716414647" sldId="257"/>
            <ac:spMk id="23" creationId="{C06ECECE-756C-8E4D-BE07-8E8206C78E94}"/>
          </ac:spMkLst>
        </pc:spChg>
        <pc:spChg chg="del">
          <ac:chgData name="Laura Martinez Verbo" userId="4d37ebe3-7a81-4ffc-b516-02451072dc6d" providerId="ADAL" clId="{F4886666-ED43-4530-9179-1FC9ED581FF0}" dt="2022-01-30T08:41:18.509" v="16" actId="478"/>
          <ac:spMkLst>
            <pc:docMk/>
            <pc:sldMk cId="3716414647" sldId="257"/>
            <ac:spMk id="24" creationId="{760EC68D-B21C-2A40-8D2A-E6E34CE31203}"/>
          </ac:spMkLst>
        </pc:spChg>
        <pc:spChg chg="del mod">
          <ac:chgData name="Laura Martinez Verbo" userId="4d37ebe3-7a81-4ffc-b516-02451072dc6d" providerId="ADAL" clId="{F4886666-ED43-4530-9179-1FC9ED581FF0}" dt="2022-01-30T08:41:16.327" v="14" actId="478"/>
          <ac:spMkLst>
            <pc:docMk/>
            <pc:sldMk cId="3716414647" sldId="257"/>
            <ac:spMk id="25" creationId="{7EC8005D-6429-1746-9686-3704631881C4}"/>
          </ac:spMkLst>
        </pc:spChg>
        <pc:spChg chg="mod">
          <ac:chgData name="Laura Martinez Verbo" userId="4d37ebe3-7a81-4ffc-b516-02451072dc6d" providerId="ADAL" clId="{F4886666-ED43-4530-9179-1FC9ED581FF0}" dt="2022-01-31T07:40:41.561" v="1212" actId="552"/>
          <ac:spMkLst>
            <pc:docMk/>
            <pc:sldMk cId="3716414647" sldId="257"/>
            <ac:spMk id="31" creationId="{B283E78F-C2AA-4948-B147-8F3BF354BD50}"/>
          </ac:spMkLst>
        </pc:spChg>
        <pc:spChg chg="add mod">
          <ac:chgData name="Laura Martinez Verbo" userId="4d37ebe3-7a81-4ffc-b516-02451072dc6d" providerId="ADAL" clId="{F4886666-ED43-4530-9179-1FC9ED581FF0}" dt="2022-01-31T07:40:41.561" v="1212" actId="552"/>
          <ac:spMkLst>
            <pc:docMk/>
            <pc:sldMk cId="3716414647" sldId="257"/>
            <ac:spMk id="47" creationId="{F1366EAD-089A-4B0F-BF83-57A9161AAF9A}"/>
          </ac:spMkLst>
        </pc:spChg>
        <pc:spChg chg="mod">
          <ac:chgData name="Laura Martinez Verbo" userId="4d37ebe3-7a81-4ffc-b516-02451072dc6d" providerId="ADAL" clId="{F4886666-ED43-4530-9179-1FC9ED581FF0}" dt="2022-01-31T07:40:41.561" v="1212" actId="552"/>
          <ac:spMkLst>
            <pc:docMk/>
            <pc:sldMk cId="3716414647" sldId="257"/>
            <ac:spMk id="49" creationId="{214C2665-F6DB-6540-B1F1-CE06C728F809}"/>
          </ac:spMkLst>
        </pc:spChg>
        <pc:grpChg chg="add del mod">
          <ac:chgData name="Laura Martinez Verbo" userId="4d37ebe3-7a81-4ffc-b516-02451072dc6d" providerId="ADAL" clId="{F4886666-ED43-4530-9179-1FC9ED581FF0}" dt="2022-01-31T07:38:28.439" v="1189" actId="478"/>
          <ac:grpSpMkLst>
            <pc:docMk/>
            <pc:sldMk cId="3716414647" sldId="257"/>
            <ac:grpSpMk id="6" creationId="{9DF0BA0C-A8D9-4E63-8F1A-0C10FCB373CB}"/>
          </ac:grpSpMkLst>
        </pc:grpChg>
        <pc:grpChg chg="add del mod">
          <ac:chgData name="Laura Martinez Verbo" userId="4d37ebe3-7a81-4ffc-b516-02451072dc6d" providerId="ADAL" clId="{F4886666-ED43-4530-9179-1FC9ED581FF0}" dt="2022-02-01T11:31:18.243" v="1237" actId="478"/>
          <ac:grpSpMkLst>
            <pc:docMk/>
            <pc:sldMk cId="3716414647" sldId="257"/>
            <ac:grpSpMk id="8" creationId="{99B86215-C607-4C2F-BB54-0777FBBABADA}"/>
          </ac:grpSpMkLst>
        </pc:grpChg>
        <pc:grpChg chg="add mod">
          <ac:chgData name="Laura Martinez Verbo" userId="4d37ebe3-7a81-4ffc-b516-02451072dc6d" providerId="ADAL" clId="{F4886666-ED43-4530-9179-1FC9ED581FF0}" dt="2022-02-01T11:32:16.770" v="1250" actId="164"/>
          <ac:grpSpMkLst>
            <pc:docMk/>
            <pc:sldMk cId="3716414647" sldId="257"/>
            <ac:grpSpMk id="9" creationId="{2D70A30F-589A-408C-970D-0F1C29B4F8AB}"/>
          </ac:grpSpMkLst>
        </pc:grpChg>
        <pc:grpChg chg="del">
          <ac:chgData name="Laura Martinez Verbo" userId="4d37ebe3-7a81-4ffc-b516-02451072dc6d" providerId="ADAL" clId="{F4886666-ED43-4530-9179-1FC9ED581FF0}" dt="2022-01-30T08:41:13.603" v="10" actId="478"/>
          <ac:grpSpMkLst>
            <pc:docMk/>
            <pc:sldMk cId="3716414647" sldId="257"/>
            <ac:grpSpMk id="19" creationId="{57B7AD23-267D-064B-8EC4-C3FC3472196F}"/>
          </ac:grpSpMkLst>
        </pc:grpChg>
        <pc:grpChg chg="add mod">
          <ac:chgData name="Laura Martinez Verbo" userId="4d37ebe3-7a81-4ffc-b516-02451072dc6d" providerId="ADAL" clId="{F4886666-ED43-4530-9179-1FC9ED581FF0}" dt="2022-01-31T07:40:47.094" v="1213" actId="552"/>
          <ac:grpSpMkLst>
            <pc:docMk/>
            <pc:sldMk cId="3716414647" sldId="257"/>
            <ac:grpSpMk id="26" creationId="{130D8889-6D3A-4437-A3FE-3488FEE03A9C}"/>
          </ac:grpSpMkLst>
        </pc:grpChg>
        <pc:grpChg chg="add del mod">
          <ac:chgData name="Laura Martinez Verbo" userId="4d37ebe3-7a81-4ffc-b516-02451072dc6d" providerId="ADAL" clId="{F4886666-ED43-4530-9179-1FC9ED581FF0}" dt="2022-01-30T09:32:20.115" v="834" actId="478"/>
          <ac:grpSpMkLst>
            <pc:docMk/>
            <pc:sldMk cId="3716414647" sldId="257"/>
            <ac:grpSpMk id="29" creationId="{0EF064CF-9D5D-4887-ADC7-C227D3AB632E}"/>
          </ac:grpSpMkLst>
        </pc:grpChg>
        <pc:grpChg chg="add del mod">
          <ac:chgData name="Laura Martinez Verbo" userId="4d37ebe3-7a81-4ffc-b516-02451072dc6d" providerId="ADAL" clId="{F4886666-ED43-4530-9179-1FC9ED581FF0}" dt="2022-01-30T09:32:22.045" v="835" actId="478"/>
          <ac:grpSpMkLst>
            <pc:docMk/>
            <pc:sldMk cId="3716414647" sldId="257"/>
            <ac:grpSpMk id="44" creationId="{00870288-BDCE-43D5-B007-193CE6B7A5E2}"/>
          </ac:grpSpMkLst>
        </pc:grpChg>
        <pc:graphicFrameChg chg="add del mod">
          <ac:chgData name="Laura Martinez Verbo" userId="4d37ebe3-7a81-4ffc-b516-02451072dc6d" providerId="ADAL" clId="{F4886666-ED43-4530-9179-1FC9ED581FF0}" dt="2022-01-30T09:33:22.935" v="855" actId="478"/>
          <ac:graphicFrameMkLst>
            <pc:docMk/>
            <pc:sldMk cId="3716414647" sldId="257"/>
            <ac:graphicFrameMk id="9" creationId="{04FE29B7-51A3-45A3-A13D-BD60CA784144}"/>
          </ac:graphicFrameMkLst>
        </pc:graphicFrameChg>
        <pc:graphicFrameChg chg="add del mod">
          <ac:chgData name="Laura Martinez Verbo" userId="4d37ebe3-7a81-4ffc-b516-02451072dc6d" providerId="ADAL" clId="{F4886666-ED43-4530-9179-1FC9ED581FF0}" dt="2022-01-30T09:33:04.025" v="847" actId="478"/>
          <ac:graphicFrameMkLst>
            <pc:docMk/>
            <pc:sldMk cId="3716414647" sldId="257"/>
            <ac:graphicFrameMk id="10" creationId="{A02ABD16-DEE8-45E7-B6B6-F802861BCD93}"/>
          </ac:graphicFrameMkLst>
        </pc:graphicFrameChg>
        <pc:picChg chg="add del mod topLvl">
          <ac:chgData name="Laura Martinez Verbo" userId="4d37ebe3-7a81-4ffc-b516-02451072dc6d" providerId="ADAL" clId="{F4886666-ED43-4530-9179-1FC9ED581FF0}" dt="2022-02-01T11:31:18.243" v="1237" actId="478"/>
          <ac:picMkLst>
            <pc:docMk/>
            <pc:sldMk cId="3716414647" sldId="257"/>
            <ac:picMk id="2" creationId="{D8774EAB-6823-4E41-A150-2E9D5CC3F9F6}"/>
          </ac:picMkLst>
        </pc:picChg>
        <pc:picChg chg="add mod topLvl modCrop">
          <ac:chgData name="Laura Martinez Verbo" userId="4d37ebe3-7a81-4ffc-b516-02451072dc6d" providerId="ADAL" clId="{F4886666-ED43-4530-9179-1FC9ED581FF0}" dt="2022-02-01T11:32:16.770" v="1250" actId="164"/>
          <ac:picMkLst>
            <pc:docMk/>
            <pc:sldMk cId="3716414647" sldId="257"/>
            <ac:picMk id="3" creationId="{6CD336E1-A3BB-48D9-BD47-B9FEA93A9BE6}"/>
          </ac:picMkLst>
        </pc:picChg>
        <pc:picChg chg="add del mod topLvl">
          <ac:chgData name="Laura Martinez Verbo" userId="4d37ebe3-7a81-4ffc-b516-02451072dc6d" providerId="ADAL" clId="{F4886666-ED43-4530-9179-1FC9ED581FF0}" dt="2022-01-31T07:38:28.439" v="1189" actId="478"/>
          <ac:picMkLst>
            <pc:docMk/>
            <pc:sldMk cId="3716414647" sldId="257"/>
            <ac:picMk id="5" creationId="{56E027B5-B807-42C7-8331-0FFC0D2D3AD8}"/>
          </ac:picMkLst>
        </pc:picChg>
        <pc:picChg chg="add mod">
          <ac:chgData name="Laura Martinez Verbo" userId="4d37ebe3-7a81-4ffc-b516-02451072dc6d" providerId="ADAL" clId="{F4886666-ED43-4530-9179-1FC9ED581FF0}" dt="2022-02-01T11:32:16.770" v="1250" actId="164"/>
          <ac:picMkLst>
            <pc:docMk/>
            <pc:sldMk cId="3716414647" sldId="257"/>
            <ac:picMk id="6" creationId="{3993681D-9E2C-4B92-9CBA-56C7FDA697FD}"/>
          </ac:picMkLst>
        </pc:picChg>
        <pc:picChg chg="add mod modCrop">
          <ac:chgData name="Laura Martinez Verbo" userId="4d37ebe3-7a81-4ffc-b516-02451072dc6d" providerId="ADAL" clId="{F4886666-ED43-4530-9179-1FC9ED581FF0}" dt="2022-01-31T07:40:47.094" v="1213" actId="552"/>
          <ac:picMkLst>
            <pc:docMk/>
            <pc:sldMk cId="3716414647" sldId="257"/>
            <ac:picMk id="7" creationId="{84860C72-9369-4BB2-9ED4-E096702B1D33}"/>
          </ac:picMkLst>
        </pc:picChg>
        <pc:picChg chg="del">
          <ac:chgData name="Laura Martinez Verbo" userId="4d37ebe3-7a81-4ffc-b516-02451072dc6d" providerId="ADAL" clId="{F4886666-ED43-4530-9179-1FC9ED581FF0}" dt="2022-01-30T08:41:12.593" v="9" actId="478"/>
          <ac:picMkLst>
            <pc:docMk/>
            <pc:sldMk cId="3716414647" sldId="257"/>
            <ac:picMk id="8" creationId="{31EB4F08-D427-D445-BB06-B1784CF0CF80}"/>
          </ac:picMkLst>
        </pc:picChg>
        <pc:picChg chg="add mod">
          <ac:chgData name="Laura Martinez Verbo" userId="4d37ebe3-7a81-4ffc-b516-02451072dc6d" providerId="ADAL" clId="{F4886666-ED43-4530-9179-1FC9ED581FF0}" dt="2022-01-30T09:34:09.935" v="869" actId="1076"/>
          <ac:picMkLst>
            <pc:docMk/>
            <pc:sldMk cId="3716414647" sldId="257"/>
            <ac:picMk id="11" creationId="{ED7B73A2-EFC7-4D9C-BE70-99AD2B867D09}"/>
          </ac:picMkLst>
        </pc:picChg>
        <pc:picChg chg="add mod">
          <ac:chgData name="Laura Martinez Verbo" userId="4d37ebe3-7a81-4ffc-b516-02451072dc6d" providerId="ADAL" clId="{F4886666-ED43-4530-9179-1FC9ED581FF0}" dt="2022-01-30T09:34:06.584" v="868" actId="554"/>
          <ac:picMkLst>
            <pc:docMk/>
            <pc:sldMk cId="3716414647" sldId="257"/>
            <ac:picMk id="12" creationId="{C09E44B1-78F0-4E5D-9ACE-D658DA72FCE9}"/>
          </ac:picMkLst>
        </pc:picChg>
        <pc:picChg chg="add mod">
          <ac:chgData name="Laura Martinez Verbo" userId="4d37ebe3-7a81-4ffc-b516-02451072dc6d" providerId="ADAL" clId="{F4886666-ED43-4530-9179-1FC9ED581FF0}" dt="2022-01-31T07:40:27.851" v="1211" actId="1076"/>
          <ac:picMkLst>
            <pc:docMk/>
            <pc:sldMk cId="3716414647" sldId="257"/>
            <ac:picMk id="13" creationId="{EF820EC9-74D6-4FD8-8807-CE8C102447B2}"/>
          </ac:picMkLst>
        </pc:picChg>
        <pc:picChg chg="del">
          <ac:chgData name="Laura Martinez Verbo" userId="4d37ebe3-7a81-4ffc-b516-02451072dc6d" providerId="ADAL" clId="{F4886666-ED43-4530-9179-1FC9ED581FF0}" dt="2022-01-30T08:41:14.685" v="12" actId="478"/>
          <ac:picMkLst>
            <pc:docMk/>
            <pc:sldMk cId="3716414647" sldId="257"/>
            <ac:picMk id="20" creationId="{8F7E3317-459B-E94B-975C-9A76B6B433A5}"/>
          </ac:picMkLst>
        </pc:picChg>
        <pc:picChg chg="mod modCrop">
          <ac:chgData name="Laura Martinez Verbo" userId="4d37ebe3-7a81-4ffc-b516-02451072dc6d" providerId="ADAL" clId="{F4886666-ED43-4530-9179-1FC9ED581FF0}" dt="2022-01-30T09:18:40.377" v="146" actId="732"/>
          <ac:picMkLst>
            <pc:docMk/>
            <pc:sldMk cId="3716414647" sldId="257"/>
            <ac:picMk id="43" creationId="{5F098B99-A95B-4319-B9AF-8DFF717995DC}"/>
          </ac:picMkLst>
        </pc:picChg>
        <pc:picChg chg="mod modCrop">
          <ac:chgData name="Laura Martinez Verbo" userId="4d37ebe3-7a81-4ffc-b516-02451072dc6d" providerId="ADAL" clId="{F4886666-ED43-4530-9179-1FC9ED581FF0}" dt="2022-01-30T09:18:48.947" v="148" actId="732"/>
          <ac:picMkLst>
            <pc:docMk/>
            <pc:sldMk cId="3716414647" sldId="257"/>
            <ac:picMk id="46" creationId="{EB78BB65-ADF6-459C-9516-3E68B52CDAD1}"/>
          </ac:picMkLst>
        </pc:picChg>
        <pc:picChg chg="del">
          <ac:chgData name="Laura Martinez Verbo" userId="4d37ebe3-7a81-4ffc-b516-02451072dc6d" providerId="ADAL" clId="{F4886666-ED43-4530-9179-1FC9ED581FF0}" dt="2022-01-30T08:41:19.240" v="17" actId="478"/>
          <ac:picMkLst>
            <pc:docMk/>
            <pc:sldMk cId="3716414647" sldId="257"/>
            <ac:picMk id="50" creationId="{38D5EA31-68FC-6042-BD4E-4C08DCF3CFEF}"/>
          </ac:picMkLst>
        </pc:picChg>
      </pc:sldChg>
      <pc:sldMasterChg chg="modSp modSldLayout">
        <pc:chgData name="Laura Martinez Verbo" userId="4d37ebe3-7a81-4ffc-b516-02451072dc6d" providerId="ADAL" clId="{F4886666-ED43-4530-9179-1FC9ED581FF0}" dt="2022-01-30T08:39:46.647" v="0"/>
        <pc:sldMasterMkLst>
          <pc:docMk/>
          <pc:sldMasterMk cId="2879341749" sldId="2147483648"/>
        </pc:sldMasterMkLst>
        <pc:spChg chg="mod">
          <ac:chgData name="Laura Martinez Verbo" userId="4d37ebe3-7a81-4ffc-b516-02451072dc6d" providerId="ADAL" clId="{F4886666-ED43-4530-9179-1FC9ED581FF0}" dt="2022-01-30T08:39:46.647" v="0"/>
          <ac:spMkLst>
            <pc:docMk/>
            <pc:sldMasterMk cId="2879341749" sldId="2147483648"/>
            <ac:spMk id="2" creationId="{7BCE6486-613B-467B-934C-F345F49E2A42}"/>
          </ac:spMkLst>
        </pc:spChg>
        <pc:spChg chg="mod">
          <ac:chgData name="Laura Martinez Verbo" userId="4d37ebe3-7a81-4ffc-b516-02451072dc6d" providerId="ADAL" clId="{F4886666-ED43-4530-9179-1FC9ED581FF0}" dt="2022-01-30T08:39:46.647" v="0"/>
          <ac:spMkLst>
            <pc:docMk/>
            <pc:sldMasterMk cId="2879341749" sldId="2147483648"/>
            <ac:spMk id="3" creationId="{CFE97888-FB52-4491-8AEF-51A5455CDBA5}"/>
          </ac:spMkLst>
        </pc:spChg>
        <pc:spChg chg="mod">
          <ac:chgData name="Laura Martinez Verbo" userId="4d37ebe3-7a81-4ffc-b516-02451072dc6d" providerId="ADAL" clId="{F4886666-ED43-4530-9179-1FC9ED581FF0}" dt="2022-01-30T08:39:46.647" v="0"/>
          <ac:spMkLst>
            <pc:docMk/>
            <pc:sldMasterMk cId="2879341749" sldId="2147483648"/>
            <ac:spMk id="4" creationId="{CC2DF41C-4E5F-49FC-8E1B-7B25F2241E0F}"/>
          </ac:spMkLst>
        </pc:spChg>
        <pc:spChg chg="mod">
          <ac:chgData name="Laura Martinez Verbo" userId="4d37ebe3-7a81-4ffc-b516-02451072dc6d" providerId="ADAL" clId="{F4886666-ED43-4530-9179-1FC9ED581FF0}" dt="2022-01-30T08:39:46.647" v="0"/>
          <ac:spMkLst>
            <pc:docMk/>
            <pc:sldMasterMk cId="2879341749" sldId="2147483648"/>
            <ac:spMk id="5" creationId="{8800CFC2-8FFC-42CF-8BEA-1EC1FF7C0332}"/>
          </ac:spMkLst>
        </pc:spChg>
        <pc:spChg chg="mod">
          <ac:chgData name="Laura Martinez Verbo" userId="4d37ebe3-7a81-4ffc-b516-02451072dc6d" providerId="ADAL" clId="{F4886666-ED43-4530-9179-1FC9ED581FF0}" dt="2022-01-30T08:39:46.647" v="0"/>
          <ac:spMkLst>
            <pc:docMk/>
            <pc:sldMasterMk cId="2879341749" sldId="2147483648"/>
            <ac:spMk id="6" creationId="{7E887FB2-B3C9-41D6-97B6-C4F2585C26DF}"/>
          </ac:spMkLst>
        </pc:sp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2393040819" sldId="2147483649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3040819" sldId="2147483649"/>
              <ac:spMk id="2" creationId="{07717DDE-9A62-4CF8-9A46-2F4322AFB5A5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3040819" sldId="2147483649"/>
              <ac:spMk id="3" creationId="{AEBFC410-660D-44A4-892A-373AC7823AEE}"/>
            </ac:spMkLst>
          </pc:spChg>
        </pc:sldLayout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3500630923" sldId="2147483651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3500630923" sldId="2147483651"/>
              <ac:spMk id="2" creationId="{C1B22D64-5065-4FCD-BCCD-E34148DF1CB3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3500630923" sldId="2147483651"/>
              <ac:spMk id="3" creationId="{0FB0D544-680D-463C-8070-428D779EE47E}"/>
            </ac:spMkLst>
          </pc:spChg>
        </pc:sldLayout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566617309" sldId="2147483652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566617309" sldId="2147483652"/>
              <ac:spMk id="3" creationId="{96D7371B-A2D4-41A7-8904-3CC4CFDE3BC0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566617309" sldId="2147483652"/>
              <ac:spMk id="4" creationId="{C8412E44-1F3B-4E64-9D05-37F0DAB6B7ED}"/>
            </ac:spMkLst>
          </pc:spChg>
        </pc:sldLayout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2397706329" sldId="2147483653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7706329" sldId="2147483653"/>
              <ac:spMk id="2" creationId="{B3A4A71A-6ED8-4D91-83CB-2E77FEC6DB58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7706329" sldId="2147483653"/>
              <ac:spMk id="3" creationId="{1B7673D9-E565-49A1-9542-C4F9B4A97DFE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7706329" sldId="2147483653"/>
              <ac:spMk id="4" creationId="{9D2D43B2-EA53-45B3-A61B-D4B3E07CED73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7706329" sldId="2147483653"/>
              <ac:spMk id="5" creationId="{37B4EDF0-442F-4FEC-BB8E-E0568BC85C8A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2397706329" sldId="2147483653"/>
              <ac:spMk id="6" creationId="{E8EDA525-1847-40B1-A7D1-94CA35C3763A}"/>
            </ac:spMkLst>
          </pc:spChg>
        </pc:sldLayout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1180587660" sldId="2147483656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180587660" sldId="2147483656"/>
              <ac:spMk id="2" creationId="{0AF4460A-670B-4050-9931-21BF16535789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180587660" sldId="2147483656"/>
              <ac:spMk id="3" creationId="{9723E2ED-E89E-45B3-8734-741B4E745776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180587660" sldId="2147483656"/>
              <ac:spMk id="4" creationId="{1289CA71-53AB-40E5-BE82-D34DA4A83F58}"/>
            </ac:spMkLst>
          </pc:spChg>
        </pc:sldLayout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1457170002" sldId="2147483657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457170002" sldId="2147483657"/>
              <ac:spMk id="2" creationId="{3B9A0F01-AFF0-4E00-837B-3E374394EF26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457170002" sldId="2147483657"/>
              <ac:spMk id="3" creationId="{489C7C1E-B18A-4D9C-A72E-93F57B3DB56A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457170002" sldId="2147483657"/>
              <ac:spMk id="4" creationId="{25E94ABC-94E6-4BFF-9C9C-3DC1E8199959}"/>
            </ac:spMkLst>
          </pc:spChg>
        </pc:sldLayoutChg>
        <pc:sldLayoutChg chg="modSp">
          <pc:chgData name="Laura Martinez Verbo" userId="4d37ebe3-7a81-4ffc-b516-02451072dc6d" providerId="ADAL" clId="{F4886666-ED43-4530-9179-1FC9ED581FF0}" dt="2022-01-30T08:39:46.647" v="0"/>
          <pc:sldLayoutMkLst>
            <pc:docMk/>
            <pc:sldMasterMk cId="2879341749" sldId="2147483648"/>
            <pc:sldLayoutMk cId="1190259013" sldId="2147483659"/>
          </pc:sldLayoutMkLst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190259013" sldId="2147483659"/>
              <ac:spMk id="2" creationId="{C9A96D4D-3A5F-4333-9F93-D40B3D466BF6}"/>
            </ac:spMkLst>
          </pc:spChg>
          <pc:spChg chg="mod">
            <ac:chgData name="Laura Martinez Verbo" userId="4d37ebe3-7a81-4ffc-b516-02451072dc6d" providerId="ADAL" clId="{F4886666-ED43-4530-9179-1FC9ED581FF0}" dt="2022-01-30T08:39:46.647" v="0"/>
            <ac:spMkLst>
              <pc:docMk/>
              <pc:sldMasterMk cId="2879341749" sldId="2147483648"/>
              <pc:sldLayoutMk cId="1190259013" sldId="2147483659"/>
              <ac:spMk id="3" creationId="{F23CECB1-B7A8-4B17-915C-0BDF27BB2BB5}"/>
            </ac:spMkLst>
          </pc:spChg>
        </pc:sldLayoutChg>
      </pc:sldMaster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545DE1A-0F7D-4EE1-B1B4-4CFA373F497D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E1A0376-187E-4B4B-8AF3-08D0730F7F8F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61793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E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E1A0376-187E-4B4B-8AF3-08D0730F7F8F}" type="slidenum">
              <a:rPr lang="es-ES" smtClean="0"/>
              <a:t>1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861709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7717DDE-9A62-4CF8-9A46-2F4322AFB5A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AEBFC410-660D-44A4-892A-373AC7823AE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3E20249-4F41-4A4F-A2E9-A95B53AFE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F558539-34F1-4718-AD7B-6F504A08A3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9529585-8B5C-4EE8-A27D-0882BB281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30408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ABCE2D5A-FC7D-4CD8-8D94-14824EA945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0D5549B-E15B-4DCE-8D9E-A591BB1E92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9DD68A6-0C3D-4ACA-88B5-78D0736144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016F596F-932A-4418-BF06-F762FADB6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DE5FDC7-F413-4D04-AE54-C3E0E86AEC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876778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C9A96D4D-3A5F-4333-9F93-D40B3D466B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F23CECB1-B7A8-4B17-915C-0BDF27BB2B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8CDF9F0-950F-4639-B1E7-FC22911D3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95025F4-059F-4E52-A87B-30B9A5628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C5C67CD-94C9-4B35-BE09-6E42A6F112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902590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41B0119-74C0-4DC0-9FBC-C49F561500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374634EA-52C4-479D-9FC8-10F508127A2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B62281C6-DE40-4CE1-93C0-89FF45B10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C18CFBF-7487-4786-A7D2-FBF84C1F0F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AB86205-C199-4612-AC7E-177BE77857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39771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1B22D64-5065-4FCD-BCCD-E34148DF1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FB0D544-680D-463C-8070-428D779EE4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E7776F8-175C-4F3C-8915-DCFD857E9A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5BAC208-84F1-4333-96AC-17DAD0608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A8C89FE-0A34-4EAB-8DA7-033001DF9D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006309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496D34-2206-4F55-962F-D6C2E2C244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6D7371B-A2D4-41A7-8904-3CC4CFDE3BC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C8412E44-1F3B-4E64-9D05-37F0DAB6B7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C4F5FEBE-8DDE-46D3-B999-FD44E4B94F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2F1DF6D4-10D1-4D9C-B93B-665BDC9BB8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83BAA72B-5032-485C-AB75-ACFB4B5965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66617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3A4A71A-6ED8-4D91-83CB-2E77FEC6DB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B7673D9-E565-49A1-9542-C4F9B4A97D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D2D43B2-EA53-45B3-A61B-D4B3E07CED7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7B4EDF0-442F-4FEC-BB8E-E0568BC85C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E8EDA525-1847-40B1-A7D1-94CA35C3763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273DC985-F20C-45DB-9590-BD85E46026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83D5097-D43B-4699-BF25-18AD520F7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1D66E503-81E2-4E3A-8606-98D8F8D043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977063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84B5B76-D854-4416-AFD1-75940A8C45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D0735C58-A76E-4478-9815-01BDBC4F2B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91D6564-DD48-47A8-B3F6-110F9BB02E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C9EBD32E-7469-435C-BE59-859E100B8C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87504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8563E845-9AFF-4AB2-82D5-9D4D51E76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5042FF83-D4C2-4233-9156-0F63E10EDE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E7528225-CE84-49B4-AC7A-CAA3190D8A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3600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0AF4460A-670B-4050-9931-21BF165357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9723E2ED-E89E-45B3-8734-741B4E74577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1289CA71-53AB-40E5-BE82-D34DA4A83F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BB6227B-9441-4403-B809-B0FF49538A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E131147-AED2-4D9A-A6DE-9BC8400142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E9D42E61-196C-4302-B4BC-E402249498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80587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B9A0F01-AFF0-4E00-837B-3E374394EF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489C7C1E-B18A-4D9C-A72E-93F57B3DB5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25E94ABC-94E6-4BFF-9C9C-3DC1E81999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Edit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BB85453-D1FB-463D-9A0B-02C9C6135F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73890E1C-8A48-4A9B-A744-CDF37B713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250BA2F-2221-4B7F-8E0A-21E2A5F072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71700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7BCE6486-613B-467B-934C-F345F49E2A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FE97888-FB52-4491-8AEF-51A5455CDB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Edit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C2DF41C-4E5F-49FC-8E1B-7B25F2241E0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E66423-9692-4587-B9EC-F268B0B8C1E8}" type="datetimeFigureOut">
              <a:rPr lang="es-ES" smtClean="0"/>
              <a:t>02/02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800CFC2-8FFC-42CF-8BEA-1EC1FF7C033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E887FB2-B3C9-41D6-97B6-C4F2585C26D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1E8F1B-4EAF-4C2F-916E-6212B2352E8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793417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03843FA6-A6E6-7049-AC71-CA2061E0CD3A}"/>
              </a:ext>
            </a:extLst>
          </p:cNvPr>
          <p:cNvSpPr txBox="1"/>
          <p:nvPr/>
        </p:nvSpPr>
        <p:spPr>
          <a:xfrm>
            <a:off x="1046541" y="4386324"/>
            <a:ext cx="729211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.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 Impact on growth and apoptosis of the DNA methylation inhibitor 5’-azacytidine (AZA) in DND41 and SW48 cancer cell lines.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) MTT assay growth assay show a reduced growth of treated cells in both DND41 and SW48 cells lines upon the use of the demethylating agent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at each time points are the mean ± SD of four biological replicates. Statistical differences were determined using an unpaired two-tailed Student’s t-test at the 96 hours final time point. *** p &lt; 0.001 (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poptosis quantification by Annexin V incorporation reveals a significant percentage of cells affected by the treatment in DND41 and SW48 cell lines. 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ata shown represent the mean ± SD of four biological replicates analyzed by unpaired two-tailed Student’s t-test. * p &lt; 0.05; *** p &lt; 0.001.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214C2665-F6DB-6540-B1F1-CE06C728F809}"/>
              </a:ext>
            </a:extLst>
          </p:cNvPr>
          <p:cNvSpPr txBox="1"/>
          <p:nvPr/>
        </p:nvSpPr>
        <p:spPr>
          <a:xfrm>
            <a:off x="840491" y="1862567"/>
            <a:ext cx="310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7" name="TextBox 30">
            <a:extLst>
              <a:ext uri="{FF2B5EF4-FFF2-40B4-BE49-F238E27FC236}">
                <a16:creationId xmlns:a16="http://schemas.microsoft.com/office/drawing/2014/main" id="{F1366EAD-089A-4B0F-BF83-57A9161AAF9A}"/>
              </a:ext>
            </a:extLst>
          </p:cNvPr>
          <p:cNvSpPr txBox="1"/>
          <p:nvPr/>
        </p:nvSpPr>
        <p:spPr>
          <a:xfrm>
            <a:off x="5955239" y="1862567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2" name="Grupo 1">
            <a:extLst>
              <a:ext uri="{FF2B5EF4-FFF2-40B4-BE49-F238E27FC236}">
                <a16:creationId xmlns:a16="http://schemas.microsoft.com/office/drawing/2014/main" id="{1D8B5B4F-514D-45A6-A4A8-7D65F714A0A0}"/>
              </a:ext>
            </a:extLst>
          </p:cNvPr>
          <p:cNvGrpSpPr/>
          <p:nvPr/>
        </p:nvGrpSpPr>
        <p:grpSpPr>
          <a:xfrm>
            <a:off x="1166993" y="2277681"/>
            <a:ext cx="4418645" cy="1675934"/>
            <a:chOff x="2397549" y="537882"/>
            <a:chExt cx="4418645" cy="1675934"/>
          </a:xfrm>
        </p:grpSpPr>
        <p:pic>
          <p:nvPicPr>
            <p:cNvPr id="3" name="Imagen 2">
              <a:extLst>
                <a:ext uri="{FF2B5EF4-FFF2-40B4-BE49-F238E27FC236}">
                  <a16:creationId xmlns:a16="http://schemas.microsoft.com/office/drawing/2014/main" id="{6CD336E1-A3BB-48D9-BD47-B9FEA93A9BE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12088" r="26085"/>
            <a:stretch/>
          </p:blipFill>
          <p:spPr>
            <a:xfrm>
              <a:off x="2397549" y="537882"/>
              <a:ext cx="2174451" cy="1675933"/>
            </a:xfrm>
            <a:prstGeom prst="rect">
              <a:avLst/>
            </a:prstGeom>
          </p:spPr>
        </p:pic>
        <p:pic>
          <p:nvPicPr>
            <p:cNvPr id="6" name="Imagen 5">
              <a:extLst>
                <a:ext uri="{FF2B5EF4-FFF2-40B4-BE49-F238E27FC236}">
                  <a16:creationId xmlns:a16="http://schemas.microsoft.com/office/drawing/2014/main" id="{3993681D-9E2C-4B92-9CBA-56C7FDA697F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12462" r="24514"/>
            <a:stretch/>
          </p:blipFill>
          <p:spPr>
            <a:xfrm>
              <a:off x="4586083" y="537882"/>
              <a:ext cx="2230111" cy="1675934"/>
            </a:xfrm>
            <a:prstGeom prst="rect">
              <a:avLst/>
            </a:prstGeom>
          </p:spPr>
        </p:pic>
      </p:grpSp>
      <p:pic>
        <p:nvPicPr>
          <p:cNvPr id="25" name="Imagen 24">
            <a:extLst>
              <a:ext uri="{FF2B5EF4-FFF2-40B4-BE49-F238E27FC236}">
                <a16:creationId xmlns:a16="http://schemas.microsoft.com/office/drawing/2014/main" id="{3993681D-9E2C-4B92-9CBA-56C7FDA697F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4048" t="18748" b="65139"/>
          <a:stretch/>
        </p:blipFill>
        <p:spPr>
          <a:xfrm>
            <a:off x="3683581" y="2474634"/>
            <a:ext cx="722054" cy="290512"/>
          </a:xfrm>
          <a:prstGeom prst="rect">
            <a:avLst/>
          </a:prstGeom>
        </p:spPr>
      </p:pic>
      <p:pic>
        <p:nvPicPr>
          <p:cNvPr id="29" name="Imagen 28">
            <a:extLst>
              <a:ext uri="{FF2B5EF4-FFF2-40B4-BE49-F238E27FC236}">
                <a16:creationId xmlns:a16="http://schemas.microsoft.com/office/drawing/2014/main" id="{3993681D-9E2C-4B92-9CBA-56C7FDA697FD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4048" t="18748" b="65139"/>
          <a:stretch/>
        </p:blipFill>
        <p:spPr>
          <a:xfrm>
            <a:off x="1583367" y="2474634"/>
            <a:ext cx="722054" cy="290512"/>
          </a:xfrm>
          <a:prstGeom prst="rect">
            <a:avLst/>
          </a:prstGeom>
        </p:spPr>
      </p:pic>
      <p:sp>
        <p:nvSpPr>
          <p:cNvPr id="21" name="TextBox 22">
            <a:extLst>
              <a:ext uri="{FF2B5EF4-FFF2-40B4-BE49-F238E27FC236}">
                <a16:creationId xmlns:a16="http://schemas.microsoft.com/office/drawing/2014/main" id="{CCFDFA84-E0B1-47C6-BD4D-4B9E9C76AB39}"/>
              </a:ext>
            </a:extLst>
          </p:cNvPr>
          <p:cNvSpPr txBox="1"/>
          <p:nvPr/>
        </p:nvSpPr>
        <p:spPr>
          <a:xfrm>
            <a:off x="7068710" y="-38461"/>
            <a:ext cx="21216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4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54675A1-EC30-E24D-8082-D78FDDCA319E}"/>
              </a:ext>
            </a:extLst>
          </p:cNvPr>
          <p:cNvSpPr txBox="1"/>
          <p:nvPr/>
        </p:nvSpPr>
        <p:spPr>
          <a:xfrm>
            <a:off x="2070583" y="2047233"/>
            <a:ext cx="60465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DND4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C7476392-DC0B-C241-8E80-43212C5E9F61}"/>
              </a:ext>
            </a:extLst>
          </p:cNvPr>
          <p:cNvSpPr txBox="1"/>
          <p:nvPr/>
        </p:nvSpPr>
        <p:spPr>
          <a:xfrm>
            <a:off x="4204323" y="2047232"/>
            <a:ext cx="53251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W48</a:t>
            </a:r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93F50FEE-E23B-8E43-8557-80D393A900C8}"/>
              </a:ext>
            </a:extLst>
          </p:cNvPr>
          <p:cNvGrpSpPr/>
          <p:nvPr/>
        </p:nvGrpSpPr>
        <p:grpSpPr>
          <a:xfrm>
            <a:off x="6124516" y="2159091"/>
            <a:ext cx="2214142" cy="1703158"/>
            <a:chOff x="987769" y="2695006"/>
            <a:chExt cx="2214142" cy="1703158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3BC86B7A-4D43-C74A-B4D9-5426F81A27AC}"/>
                </a:ext>
              </a:extLst>
            </p:cNvPr>
            <p:cNvSpPr txBox="1"/>
            <p:nvPr/>
          </p:nvSpPr>
          <p:spPr>
            <a:xfrm>
              <a:off x="1345579" y="4149348"/>
              <a:ext cx="60465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ND41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4BDA4A3-0AA2-F44C-9F75-7AB88320FD8F}"/>
                </a:ext>
              </a:extLst>
            </p:cNvPr>
            <p:cNvSpPr txBox="1"/>
            <p:nvPr/>
          </p:nvSpPr>
          <p:spPr>
            <a:xfrm>
              <a:off x="1865031" y="4151943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SW48</a:t>
              </a:r>
            </a:p>
          </p:txBody>
        </p:sp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3A0ADCB6-D615-4342-A3F3-229C5CD96B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t="15103" b="10351"/>
            <a:stretch/>
          </p:blipFill>
          <p:spPr>
            <a:xfrm>
              <a:off x="987769" y="2695006"/>
              <a:ext cx="2214142" cy="1480777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1641464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158</Words>
  <Application>Microsoft Office PowerPoint</Application>
  <PresentationFormat>Presentación en pantalla (4:3)</PresentationFormat>
  <Paragraphs>9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aura Martinez Verbo</dc:creator>
  <cp:lastModifiedBy>Manel Esteller</cp:lastModifiedBy>
  <cp:revision>27</cp:revision>
  <dcterms:created xsi:type="dcterms:W3CDTF">2022-01-30T08:39:40Z</dcterms:created>
  <dcterms:modified xsi:type="dcterms:W3CDTF">2022-02-02T17:12:10Z</dcterms:modified>
</cp:coreProperties>
</file>